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4"/>
  </p:sldMasterIdLst>
  <p:sldIdLst>
    <p:sldId id="256" r:id="rId5"/>
  </p:sldIdLst>
  <p:sldSz cx="6858000" cy="111125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suno Kanami" initials="TK" lastIdx="2" clrIdx="0">
    <p:extLst>
      <p:ext uri="{19B8F6BF-5375-455C-9EA6-DF929625EA0E}">
        <p15:presenceInfo xmlns:p15="http://schemas.microsoft.com/office/powerpoint/2012/main" userId="23351eff6ce6234f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C88F745-7508-4ECA-B32F-B7EDCBE8ECAC}" v="3" dt="2021-03-31T21:43:20.82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1" d="100"/>
          <a:sy n="41" d="100"/>
        </p:scale>
        <p:origin x="231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commentAuthors" Target="commentAuthor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818644"/>
            <a:ext cx="5829300" cy="386879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836635"/>
            <a:ext cx="5143500" cy="2682948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4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87198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4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3598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91638"/>
            <a:ext cx="1478756" cy="941733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91638"/>
            <a:ext cx="4350544" cy="941733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4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95369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4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7673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770411"/>
            <a:ext cx="5915025" cy="462249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7436632"/>
            <a:ext cx="5915025" cy="243085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4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36402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958189"/>
            <a:ext cx="2914650" cy="70507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958189"/>
            <a:ext cx="2914650" cy="70507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4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4983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91640"/>
            <a:ext cx="5915025" cy="214790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724107"/>
            <a:ext cx="2901255" cy="133504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059149"/>
            <a:ext cx="2901255" cy="597039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724107"/>
            <a:ext cx="2915543" cy="133504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059149"/>
            <a:ext cx="2915543" cy="597039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4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89637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4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762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4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0477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40833"/>
            <a:ext cx="2211884" cy="2592917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599996"/>
            <a:ext cx="3471863" cy="789707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333750"/>
            <a:ext cx="2211884" cy="617618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4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174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40833"/>
            <a:ext cx="2211884" cy="2592917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599996"/>
            <a:ext cx="3471863" cy="789707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333750"/>
            <a:ext cx="2211884" cy="617618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4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4533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91640"/>
            <a:ext cx="5915025" cy="21479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958189"/>
            <a:ext cx="5915025" cy="70507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0299644"/>
            <a:ext cx="1543050" cy="59163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69912-DECC-4E1E-AE6C-2633F5907711}" type="datetimeFigureOut">
              <a:rPr kumimoji="1" lang="ja-JP" altLang="en-US" smtClean="0"/>
              <a:t>2021/4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0299644"/>
            <a:ext cx="2314575" cy="59163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0299644"/>
            <a:ext cx="1543050" cy="59163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5749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459A75F7-8CF7-4954-AC74-2B969CE8EBED}"/>
              </a:ext>
            </a:extLst>
          </p:cNvPr>
          <p:cNvSpPr/>
          <p:nvPr/>
        </p:nvSpPr>
        <p:spPr>
          <a:xfrm>
            <a:off x="1047920" y="856832"/>
            <a:ext cx="5040348" cy="398266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tential candidates from the online database of internet survey company</a:t>
            </a:r>
            <a:endParaRPr kumimoji="1" lang="ja-JP" alt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F583C30E-7086-46C3-BA0D-E427BEC6E1F8}"/>
              </a:ext>
            </a:extLst>
          </p:cNvPr>
          <p:cNvSpPr/>
          <p:nvPr/>
        </p:nvSpPr>
        <p:spPr>
          <a:xfrm>
            <a:off x="1040769" y="9845836"/>
            <a:ext cx="5040345" cy="740880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tic sample (n=875)</a:t>
            </a:r>
          </a:p>
          <a:p>
            <a:pPr algn="ctr"/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 who responded at T2 and T3 and currently employed</a:t>
            </a:r>
          </a:p>
          <a:p>
            <a:pPr algn="ctr"/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.4%</a:t>
            </a:r>
            <a:r>
              <a:rPr kumimoji="1" lang="ja-JP" altLang="en-US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kumimoji="1" lang="ja-JP" altLang="en-US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1</a:t>
            </a:r>
            <a:r>
              <a:rPr kumimoji="1" lang="ja-JP" altLang="en-US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dents.</a:t>
            </a:r>
            <a:endParaRPr kumimoji="1" lang="ja-JP" alt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3A08312D-A291-4A6D-BDE9-9A4CA076CECB}"/>
              </a:ext>
            </a:extLst>
          </p:cNvPr>
          <p:cNvSpPr/>
          <p:nvPr/>
        </p:nvSpPr>
        <p:spPr>
          <a:xfrm>
            <a:off x="4613483" y="7329101"/>
            <a:ext cx="1458495" cy="398266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employed (n=17)</a:t>
            </a:r>
            <a:endParaRPr kumimoji="1" lang="ja-JP" alt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A2F43820-3FDA-4098-93A0-41B92E6AFF12}"/>
              </a:ext>
            </a:extLst>
          </p:cNvPr>
          <p:cNvCxnSpPr>
            <a:cxnSpLocks/>
          </p:cNvCxnSpPr>
          <p:nvPr/>
        </p:nvCxnSpPr>
        <p:spPr>
          <a:xfrm>
            <a:off x="3518667" y="7512884"/>
            <a:ext cx="109481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3899F7B-AB6F-4303-83F9-7AC29937C49A}"/>
              </a:ext>
            </a:extLst>
          </p:cNvPr>
          <p:cNvSpPr txBox="1"/>
          <p:nvPr/>
        </p:nvSpPr>
        <p:spPr>
          <a:xfrm>
            <a:off x="1213123" y="10690895"/>
            <a:ext cx="46201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Flowchart of participant recruitment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7FDF2885-5D14-46D3-894E-3F864101EE20}"/>
              </a:ext>
            </a:extLst>
          </p:cNvPr>
          <p:cNvCxnSpPr>
            <a:cxnSpLocks/>
          </p:cNvCxnSpPr>
          <p:nvPr/>
        </p:nvCxnSpPr>
        <p:spPr>
          <a:xfrm>
            <a:off x="3535343" y="1259840"/>
            <a:ext cx="0" cy="68978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34859092-CB54-4D36-9EFF-50EBDDAE6F5B}"/>
              </a:ext>
            </a:extLst>
          </p:cNvPr>
          <p:cNvSpPr/>
          <p:nvPr/>
        </p:nvSpPr>
        <p:spPr>
          <a:xfrm>
            <a:off x="1049912" y="4184567"/>
            <a:ext cx="5040348" cy="821870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id response for T1 (N=1,448)</a:t>
            </a:r>
          </a:p>
          <a:p>
            <a:pPr algn="ctr"/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sponse rate: 35.1%</a:t>
            </a:r>
            <a:endParaRPr kumimoji="1" lang="en-US" altLang="ja-JP" sz="1201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2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Recruited first 1500 who consented to participate)</a:t>
            </a:r>
            <a:endParaRPr kumimoji="1" lang="ja-JP" altLang="en-US" sz="120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BB28F482-9053-4AAC-B6EC-D4704794BADC}"/>
              </a:ext>
            </a:extLst>
          </p:cNvPr>
          <p:cNvSpPr/>
          <p:nvPr/>
        </p:nvSpPr>
        <p:spPr>
          <a:xfrm>
            <a:off x="1049913" y="5623323"/>
            <a:ext cx="5040348" cy="398266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didate for T2 survey (N=1,421)</a:t>
            </a:r>
            <a:endParaRPr kumimoji="1" lang="ja-JP" alt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F259C8DE-66FF-41B0-85A5-AE39C83D08D6}"/>
              </a:ext>
            </a:extLst>
          </p:cNvPr>
          <p:cNvSpPr/>
          <p:nvPr/>
        </p:nvSpPr>
        <p:spPr>
          <a:xfrm>
            <a:off x="1040774" y="6642907"/>
            <a:ext cx="5040348" cy="557435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id response for T2 (N=1,032)</a:t>
            </a:r>
          </a:p>
          <a:p>
            <a:pPr algn="ctr"/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sponse rate: 72.6%</a:t>
            </a:r>
            <a:endParaRPr kumimoji="1" lang="ja-JP" altLang="en-US" sz="1201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D07C276C-E74F-45AC-988E-675C8F05A161}"/>
              </a:ext>
            </a:extLst>
          </p:cNvPr>
          <p:cNvSpPr/>
          <p:nvPr/>
        </p:nvSpPr>
        <p:spPr>
          <a:xfrm>
            <a:off x="1040770" y="1949623"/>
            <a:ext cx="5040348" cy="608041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lected a cohort of full-time employees (February 2019) (N=4,120)</a:t>
            </a:r>
          </a:p>
          <a:p>
            <a:pPr algn="ctr"/>
            <a:r>
              <a:rPr kumimoji="1" lang="en-US" altLang="ja-JP" sz="12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Recruited first 4000 who consented to participate) </a:t>
            </a:r>
            <a:endParaRPr kumimoji="1" lang="ja-JP" altLang="en-US" sz="120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AF92C60F-C0F8-47A7-94F3-F7B5DBCCBCEC}"/>
              </a:ext>
            </a:extLst>
          </p:cNvPr>
          <p:cNvSpPr/>
          <p:nvPr/>
        </p:nvSpPr>
        <p:spPr>
          <a:xfrm>
            <a:off x="1049912" y="3171373"/>
            <a:ext cx="5040348" cy="398266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didate for T1 survey (N=4,120)</a:t>
            </a:r>
            <a:endParaRPr kumimoji="1" lang="ja-JP" alt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直線矢印コネクタ 61">
            <a:extLst>
              <a:ext uri="{FF2B5EF4-FFF2-40B4-BE49-F238E27FC236}">
                <a16:creationId xmlns:a16="http://schemas.microsoft.com/office/drawing/2014/main" id="{6E20498C-E858-470E-9AC4-5CF79499D58D}"/>
              </a:ext>
            </a:extLst>
          </p:cNvPr>
          <p:cNvCxnSpPr>
            <a:cxnSpLocks/>
          </p:cNvCxnSpPr>
          <p:nvPr/>
        </p:nvCxnSpPr>
        <p:spPr>
          <a:xfrm>
            <a:off x="3540446" y="2557664"/>
            <a:ext cx="0" cy="58711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矢印コネクタ 62">
            <a:extLst>
              <a:ext uri="{FF2B5EF4-FFF2-40B4-BE49-F238E27FC236}">
                <a16:creationId xmlns:a16="http://schemas.microsoft.com/office/drawing/2014/main" id="{64A612D4-CE00-4461-8555-5B7206240382}"/>
              </a:ext>
            </a:extLst>
          </p:cNvPr>
          <p:cNvCxnSpPr>
            <a:cxnSpLocks/>
          </p:cNvCxnSpPr>
          <p:nvPr/>
        </p:nvCxnSpPr>
        <p:spPr>
          <a:xfrm>
            <a:off x="3532764" y="3572108"/>
            <a:ext cx="0" cy="58711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矢印コネクタ 63">
            <a:extLst>
              <a:ext uri="{FF2B5EF4-FFF2-40B4-BE49-F238E27FC236}">
                <a16:creationId xmlns:a16="http://schemas.microsoft.com/office/drawing/2014/main" id="{7BDE14C6-4E0D-43A0-A063-E1354B3822BC}"/>
              </a:ext>
            </a:extLst>
          </p:cNvPr>
          <p:cNvCxnSpPr>
            <a:cxnSpLocks/>
          </p:cNvCxnSpPr>
          <p:nvPr/>
        </p:nvCxnSpPr>
        <p:spPr>
          <a:xfrm>
            <a:off x="3536947" y="4997908"/>
            <a:ext cx="0" cy="58711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矢印コネクタ 64">
            <a:extLst>
              <a:ext uri="{FF2B5EF4-FFF2-40B4-BE49-F238E27FC236}">
                <a16:creationId xmlns:a16="http://schemas.microsoft.com/office/drawing/2014/main" id="{F282A0D3-3973-423F-8601-A3DD2C0FBBDD}"/>
              </a:ext>
            </a:extLst>
          </p:cNvPr>
          <p:cNvCxnSpPr>
            <a:cxnSpLocks/>
          </p:cNvCxnSpPr>
          <p:nvPr/>
        </p:nvCxnSpPr>
        <p:spPr>
          <a:xfrm>
            <a:off x="3536943" y="6021588"/>
            <a:ext cx="0" cy="58711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矢印コネクタ 65">
            <a:extLst>
              <a:ext uri="{FF2B5EF4-FFF2-40B4-BE49-F238E27FC236}">
                <a16:creationId xmlns:a16="http://schemas.microsoft.com/office/drawing/2014/main" id="{6EAD1E38-973D-47B2-B3F9-BA4FE6FA1FE1}"/>
              </a:ext>
            </a:extLst>
          </p:cNvPr>
          <p:cNvCxnSpPr>
            <a:cxnSpLocks/>
          </p:cNvCxnSpPr>
          <p:nvPr/>
        </p:nvCxnSpPr>
        <p:spPr>
          <a:xfrm>
            <a:off x="3527859" y="7219327"/>
            <a:ext cx="0" cy="29355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矢印コネクタ 67">
            <a:extLst>
              <a:ext uri="{FF2B5EF4-FFF2-40B4-BE49-F238E27FC236}">
                <a16:creationId xmlns:a16="http://schemas.microsoft.com/office/drawing/2014/main" id="{0091DAD7-3CE7-4933-B432-0F59D01D2B4F}"/>
              </a:ext>
            </a:extLst>
          </p:cNvPr>
          <p:cNvCxnSpPr>
            <a:cxnSpLocks/>
          </p:cNvCxnSpPr>
          <p:nvPr/>
        </p:nvCxnSpPr>
        <p:spPr>
          <a:xfrm>
            <a:off x="3536943" y="5291465"/>
            <a:ext cx="109481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8BDDA18F-B9E0-4315-8CF0-028D7E9B6CC6}"/>
              </a:ext>
            </a:extLst>
          </p:cNvPr>
          <p:cNvSpPr/>
          <p:nvPr/>
        </p:nvSpPr>
        <p:spPr>
          <a:xfrm>
            <a:off x="4631759" y="5085768"/>
            <a:ext cx="1458495" cy="398266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employed (n=27)</a:t>
            </a:r>
            <a:endParaRPr kumimoji="1" lang="ja-JP" alt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0091DAD7-3CE7-4933-B432-0F59D01D2B4F}"/>
              </a:ext>
            </a:extLst>
          </p:cNvPr>
          <p:cNvCxnSpPr>
            <a:cxnSpLocks/>
          </p:cNvCxnSpPr>
          <p:nvPr/>
        </p:nvCxnSpPr>
        <p:spPr>
          <a:xfrm>
            <a:off x="3536943" y="3841673"/>
            <a:ext cx="81184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8BDDA18F-B9E0-4315-8CF0-028D7E9B6CC6}"/>
              </a:ext>
            </a:extLst>
          </p:cNvPr>
          <p:cNvSpPr/>
          <p:nvPr/>
        </p:nvSpPr>
        <p:spPr>
          <a:xfrm>
            <a:off x="4348788" y="3652121"/>
            <a:ext cx="1732330" cy="398266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responded (n=2,672)</a:t>
            </a:r>
            <a:endParaRPr kumimoji="1" lang="ja-JP" alt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0091DAD7-3CE7-4933-B432-0F59D01D2B4F}"/>
              </a:ext>
            </a:extLst>
          </p:cNvPr>
          <p:cNvCxnSpPr>
            <a:cxnSpLocks/>
          </p:cNvCxnSpPr>
          <p:nvPr/>
        </p:nvCxnSpPr>
        <p:spPr>
          <a:xfrm>
            <a:off x="3536943" y="6342637"/>
            <a:ext cx="109481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8BDDA18F-B9E0-4315-8CF0-028D7E9B6CC6}"/>
              </a:ext>
            </a:extLst>
          </p:cNvPr>
          <p:cNvSpPr/>
          <p:nvPr/>
        </p:nvSpPr>
        <p:spPr>
          <a:xfrm>
            <a:off x="4631759" y="6136940"/>
            <a:ext cx="1458495" cy="398266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responded (n=389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5D4BB37-D2A6-4F60-BA97-A3E86415B6B5}"/>
              </a:ext>
            </a:extLst>
          </p:cNvPr>
          <p:cNvSpPr/>
          <p:nvPr/>
        </p:nvSpPr>
        <p:spPr>
          <a:xfrm>
            <a:off x="1049908" y="7846197"/>
            <a:ext cx="5040348" cy="398266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didate for T3 survey (</a:t>
            </a:r>
            <a:r>
              <a:rPr kumimoji="1" lang="en-US" altLang="ja-JP" sz="12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1,015</a:t>
            </a:r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25D4F24C-712C-419C-9632-2B3A80320013}"/>
              </a:ext>
            </a:extLst>
          </p:cNvPr>
          <p:cNvCxnSpPr>
            <a:cxnSpLocks/>
          </p:cNvCxnSpPr>
          <p:nvPr/>
        </p:nvCxnSpPr>
        <p:spPr>
          <a:xfrm>
            <a:off x="3505138" y="8244464"/>
            <a:ext cx="0" cy="58711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2450D1E0-90FF-40A8-9669-CA976E294C0A}"/>
              </a:ext>
            </a:extLst>
          </p:cNvPr>
          <p:cNvSpPr/>
          <p:nvPr/>
        </p:nvSpPr>
        <p:spPr>
          <a:xfrm>
            <a:off x="1049908" y="8839865"/>
            <a:ext cx="5040348" cy="557435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id response for T3 (N=</a:t>
            </a:r>
            <a:r>
              <a:rPr kumimoji="1" lang="en-US" altLang="ja-JP" sz="1201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75</a:t>
            </a:r>
            <a:r>
              <a:rPr kumimoji="1" lang="en-US" altLang="ja-JP" sz="12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pPr algn="ctr"/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sponse rate: </a:t>
            </a:r>
            <a:r>
              <a:rPr kumimoji="1" lang="en-US" altLang="ja-JP" sz="12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6.2</a:t>
            </a:r>
            <a:r>
              <a:rPr kumimoji="1"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endParaRPr kumimoji="1" lang="ja-JP" altLang="en-US" sz="1201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線矢印コネクタ 37">
            <a:extLst>
              <a:ext uri="{FF2B5EF4-FFF2-40B4-BE49-F238E27FC236}">
                <a16:creationId xmlns:a16="http://schemas.microsoft.com/office/drawing/2014/main" id="{FD083EE6-A3C0-4142-8E3C-99A638257D85}"/>
              </a:ext>
            </a:extLst>
          </p:cNvPr>
          <p:cNvCxnSpPr>
            <a:cxnSpLocks/>
          </p:cNvCxnSpPr>
          <p:nvPr/>
        </p:nvCxnSpPr>
        <p:spPr>
          <a:xfrm>
            <a:off x="3501214" y="8544586"/>
            <a:ext cx="109481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7FDFAF7A-C8E5-4892-804F-5E0983E77260}"/>
              </a:ext>
            </a:extLst>
          </p:cNvPr>
          <p:cNvSpPr/>
          <p:nvPr/>
        </p:nvSpPr>
        <p:spPr>
          <a:xfrm>
            <a:off x="4596030" y="8338889"/>
            <a:ext cx="1458495" cy="398266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responded (n=</a:t>
            </a:r>
            <a:r>
              <a:rPr kumimoji="1"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線矢印コネクタ 42">
            <a:extLst>
              <a:ext uri="{FF2B5EF4-FFF2-40B4-BE49-F238E27FC236}">
                <a16:creationId xmlns:a16="http://schemas.microsoft.com/office/drawing/2014/main" id="{7936D7CE-72D6-4F08-9611-18CD0F0EEC23}"/>
              </a:ext>
            </a:extLst>
          </p:cNvPr>
          <p:cNvCxnSpPr>
            <a:cxnSpLocks/>
          </p:cNvCxnSpPr>
          <p:nvPr/>
        </p:nvCxnSpPr>
        <p:spPr>
          <a:xfrm>
            <a:off x="3501213" y="9397300"/>
            <a:ext cx="0" cy="44853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6EAD1E38-973D-47B2-B3F9-BA4FE6FA1FE1}"/>
              </a:ext>
            </a:extLst>
          </p:cNvPr>
          <p:cNvCxnSpPr>
            <a:cxnSpLocks/>
          </p:cNvCxnSpPr>
          <p:nvPr/>
        </p:nvCxnSpPr>
        <p:spPr>
          <a:xfrm>
            <a:off x="3527859" y="7552641"/>
            <a:ext cx="0" cy="29355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39724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217F3E2742D45E42BC49FC9F3CA2B4E9" ma:contentTypeVersion="9" ma:contentTypeDescription="新しいドキュメントを作成します。" ma:contentTypeScope="" ma:versionID="bfc76f3fbb6eb56ca7bfd056ea046589">
  <xsd:schema xmlns:xsd="http://www.w3.org/2001/XMLSchema" xmlns:xs="http://www.w3.org/2001/XMLSchema" xmlns:p="http://schemas.microsoft.com/office/2006/metadata/properties" xmlns:ns3="cd7e3afa-f74e-40f6-a310-71641e90361d" targetNamespace="http://schemas.microsoft.com/office/2006/metadata/properties" ma:root="true" ma:fieldsID="3375173bda60a53364b0f75f6a75e1f1" ns3:_="">
    <xsd:import namespace="cd7e3afa-f74e-40f6-a310-71641e90361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d7e3afa-f74e-40f6-a310-71641e90361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5A543610-6427-4840-A18B-CC3FDC6DE6E9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C71B3348-590B-41EA-80C0-C1504E2D04B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d7e3afa-f74e-40f6-a310-71641e90361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8947287C-C250-4728-BA42-4E4F5DE5C6B7}">
  <ds:schemaRefs>
    <ds:schemaRef ds:uri="http://purl.org/dc/dcmitype/"/>
    <ds:schemaRef ds:uri="http://schemas.microsoft.com/office/2006/metadata/properties"/>
    <ds:schemaRef ds:uri="http://schemas.microsoft.com/office/2006/documentManagement/types"/>
    <ds:schemaRef ds:uri="http://schemas.microsoft.com/office/infopath/2007/PartnerControls"/>
    <ds:schemaRef ds:uri="http://purl.org/dc/terms/"/>
    <ds:schemaRef ds:uri="http://schemas.openxmlformats.org/package/2006/metadata/core-properties"/>
    <ds:schemaRef ds:uri="http://purl.org/dc/elements/1.1/"/>
    <ds:schemaRef ds:uri="cd7e3afa-f74e-40f6-a310-71641e90361d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11</TotalTime>
  <Words>180</Words>
  <Application>Microsoft Office PowerPoint</Application>
  <PresentationFormat>ユーザー設定</PresentationFormat>
  <Paragraphs>2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々木　那津</dc:creator>
  <cp:lastModifiedBy>9374297754@utac.u-tokyo.ac.jp</cp:lastModifiedBy>
  <cp:revision>25</cp:revision>
  <dcterms:created xsi:type="dcterms:W3CDTF">2020-07-07T00:46:37Z</dcterms:created>
  <dcterms:modified xsi:type="dcterms:W3CDTF">2021-03-31T21:43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17F3E2742D45E42BC49FC9F3CA2B4E9</vt:lpwstr>
  </property>
</Properties>
</file>